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3400" y="744120"/>
            <a:ext cx="279072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CE2BCD-3499-4843-8C1F-DE6BDE1C9D0F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79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Segnaposto numero diapositiva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E59E32-BB9A-48CB-9358-E0C1924A4182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78808-5368-43B6-97A4-8F5859FFD1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664469-121D-46B0-83CF-DDACAC47EB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57B30-22CD-481B-A87F-804C8BD8D5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3E0D9-8CF8-498E-967A-F3ECA4735F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BE012-5578-4538-B4A0-99B4783240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FB3F4-C555-4510-8A55-31B0450D76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09897-8672-4B5E-AC2D-56222EFEA4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F2CBA6-5621-4C98-AFBC-1D867F90D2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34EED-717A-4D44-B9E1-97C3CB6D87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9F95A6-F11E-4B88-8298-DCE0C08555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237135-7CEB-43D5-A72F-465F210457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A2E36-AA58-4AD3-B1F5-739330D40A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50F2C2-9DA6-4297-93A3-3CA2AF7B1D10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CasellaDiTesto 3"/>
          <p:cNvSpPr/>
          <p:nvPr/>
        </p:nvSpPr>
        <p:spPr>
          <a:xfrm>
            <a:off x="-316080" y="6588000"/>
            <a:ext cx="706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Lo Iacono et al., Fig. S4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sellaDiTesto 39"/>
          <p:cNvSpPr/>
          <p:nvPr/>
        </p:nvSpPr>
        <p:spPr>
          <a:xfrm>
            <a:off x="771480" y="4089240"/>
            <a:ext cx="27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CasellaDiTesto 40"/>
          <p:cNvSpPr/>
          <p:nvPr/>
        </p:nvSpPr>
        <p:spPr>
          <a:xfrm>
            <a:off x="619200" y="3710160"/>
            <a:ext cx="43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CasellaDiTesto 41"/>
          <p:cNvSpPr/>
          <p:nvPr/>
        </p:nvSpPr>
        <p:spPr>
          <a:xfrm>
            <a:off x="620640" y="332748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CasellaDiTesto 42"/>
          <p:cNvSpPr/>
          <p:nvPr/>
        </p:nvSpPr>
        <p:spPr>
          <a:xfrm>
            <a:off x="633240" y="2933640"/>
            <a:ext cx="47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3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CasellaDiTesto 43"/>
          <p:cNvSpPr/>
          <p:nvPr/>
        </p:nvSpPr>
        <p:spPr>
          <a:xfrm>
            <a:off x="620640" y="254952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asellaDiTesto 8"/>
          <p:cNvSpPr/>
          <p:nvPr/>
        </p:nvSpPr>
        <p:spPr>
          <a:xfrm>
            <a:off x="1230120" y="267480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  <a:ea typeface="Arial"/>
              </a:rPr>
              <a:t>ES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CasellaDiTesto 9"/>
          <p:cNvSpPr/>
          <p:nvPr/>
        </p:nvSpPr>
        <p:spPr>
          <a:xfrm rot="16200000">
            <a:off x="-52560" y="3151080"/>
            <a:ext cx="124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FST-Immobility</a:t>
            </a:r>
            <a:r>
              <a:rPr b="0" lang="it-IT" sz="1200" spc="-1" strike="noStrike">
                <a:solidFill>
                  <a:srgbClr val="000000"/>
                </a:solidFill>
                <a:latin typeface="Arial"/>
                <a:ea typeface="Arial"/>
              </a:rPr>
              <a:t> (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CasellaDiTesto 9"/>
          <p:cNvSpPr/>
          <p:nvPr/>
        </p:nvSpPr>
        <p:spPr>
          <a:xfrm>
            <a:off x="2957400" y="3708360"/>
            <a:ext cx="930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Vehic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ttangolo 11"/>
          <p:cNvSpPr/>
          <p:nvPr/>
        </p:nvSpPr>
        <p:spPr>
          <a:xfrm>
            <a:off x="2860560" y="3755880"/>
            <a:ext cx="142920" cy="1558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ttangolo 12"/>
          <p:cNvSpPr/>
          <p:nvPr/>
        </p:nvSpPr>
        <p:spPr>
          <a:xfrm>
            <a:off x="2860560" y="3956040"/>
            <a:ext cx="142920" cy="144360"/>
          </a:xfrm>
          <a:prstGeom prst="rect">
            <a:avLst/>
          </a:prstGeom>
          <a:solidFill>
            <a:srgbClr val="7f7f7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CasellaDiTesto 86"/>
          <p:cNvSpPr/>
          <p:nvPr/>
        </p:nvSpPr>
        <p:spPr>
          <a:xfrm>
            <a:off x="407160" y="19796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CasellaDiTesto 10"/>
          <p:cNvSpPr/>
          <p:nvPr/>
        </p:nvSpPr>
        <p:spPr>
          <a:xfrm>
            <a:off x="2963880" y="3902040"/>
            <a:ext cx="133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Resvera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Grafico 15" descr=""/>
          <p:cNvPicPr/>
          <p:nvPr/>
        </p:nvPicPr>
        <p:blipFill>
          <a:blip r:embed="rId1"/>
          <a:stretch/>
        </p:blipFill>
        <p:spPr>
          <a:xfrm>
            <a:off x="858960" y="2523960"/>
            <a:ext cx="2249280" cy="1839960"/>
          </a:xfrm>
          <a:prstGeom prst="rect">
            <a:avLst/>
          </a:prstGeom>
          <a:ln w="0">
            <a:noFill/>
          </a:ln>
        </p:spPr>
      </p:pic>
      <p:sp>
        <p:nvSpPr>
          <p:cNvPr id="62" name="CasellaDiTesto 16"/>
          <p:cNvSpPr/>
          <p:nvPr/>
        </p:nvSpPr>
        <p:spPr>
          <a:xfrm>
            <a:off x="1031760" y="4222800"/>
            <a:ext cx="936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  <a:ea typeface="Arial"/>
              </a:rPr>
              <a:t>Pre treat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CasellaDiTesto 17"/>
          <p:cNvSpPr/>
          <p:nvPr/>
        </p:nvSpPr>
        <p:spPr>
          <a:xfrm>
            <a:off x="2095560" y="4232160"/>
            <a:ext cx="826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  <a:ea typeface="Arial"/>
              </a:rPr>
              <a:t>Pos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  <a:ea typeface="Arial"/>
              </a:rPr>
              <a:t>treat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" name="Gruppo 1"/>
          <p:cNvGrpSpPr/>
          <p:nvPr/>
        </p:nvGrpSpPr>
        <p:grpSpPr>
          <a:xfrm>
            <a:off x="3962520" y="2000160"/>
            <a:ext cx="3138480" cy="2332080"/>
            <a:chOff x="3962520" y="2000160"/>
            <a:chExt cx="3138480" cy="2332080"/>
          </a:xfrm>
        </p:grpSpPr>
        <p:pic>
          <p:nvPicPr>
            <p:cNvPr id="65" name="Grafico 21" descr=""/>
            <p:cNvPicPr/>
            <p:nvPr/>
          </p:nvPicPr>
          <p:blipFill>
            <a:blip r:embed="rId2"/>
            <a:stretch/>
          </p:blipFill>
          <p:spPr>
            <a:xfrm>
              <a:off x="4444560" y="2515320"/>
              <a:ext cx="1523520" cy="1816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CasellaDiTesto 39"/>
            <p:cNvSpPr/>
            <p:nvPr/>
          </p:nvSpPr>
          <p:spPr>
            <a:xfrm>
              <a:off x="4300920" y="4064760"/>
              <a:ext cx="27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CasellaDiTesto 40"/>
            <p:cNvSpPr/>
            <p:nvPr/>
          </p:nvSpPr>
          <p:spPr>
            <a:xfrm>
              <a:off x="4147200" y="3686400"/>
              <a:ext cx="429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CasellaDiTesto 41"/>
            <p:cNvSpPr/>
            <p:nvPr/>
          </p:nvSpPr>
          <p:spPr>
            <a:xfrm>
              <a:off x="4149000" y="3305520"/>
              <a:ext cx="475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CasellaDiTesto 42"/>
            <p:cNvSpPr/>
            <p:nvPr/>
          </p:nvSpPr>
          <p:spPr>
            <a:xfrm>
              <a:off x="4162320" y="2912760"/>
              <a:ext cx="47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CasellaDiTesto 43"/>
            <p:cNvSpPr/>
            <p:nvPr/>
          </p:nvSpPr>
          <p:spPr>
            <a:xfrm>
              <a:off x="4149000" y="2530080"/>
              <a:ext cx="475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CasellaDiTesto 33"/>
            <p:cNvSpPr/>
            <p:nvPr/>
          </p:nvSpPr>
          <p:spPr>
            <a:xfrm rot="16200000">
              <a:off x="3476160" y="3129120"/>
              <a:ext cx="1249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ST-Immobility</a:t>
              </a: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(s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CasellaDiTesto 9"/>
            <p:cNvSpPr/>
            <p:nvPr/>
          </p:nvSpPr>
          <p:spPr>
            <a:xfrm>
              <a:off x="5768280" y="3690360"/>
              <a:ext cx="93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Vehicl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ttangolo 38"/>
            <p:cNvSpPr/>
            <p:nvPr/>
          </p:nvSpPr>
          <p:spPr>
            <a:xfrm>
              <a:off x="5671440" y="3738240"/>
              <a:ext cx="142560" cy="1548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ttangolo 39"/>
            <p:cNvSpPr/>
            <p:nvPr/>
          </p:nvSpPr>
          <p:spPr>
            <a:xfrm>
              <a:off x="5671440" y="3937680"/>
              <a:ext cx="142560" cy="1440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CasellaDiTesto 10"/>
            <p:cNvSpPr/>
            <p:nvPr/>
          </p:nvSpPr>
          <p:spPr>
            <a:xfrm>
              <a:off x="5766840" y="3880440"/>
              <a:ext cx="1334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lisista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CasellaDiTesto 41"/>
            <p:cNvSpPr/>
            <p:nvPr/>
          </p:nvSpPr>
          <p:spPr>
            <a:xfrm>
              <a:off x="4522320" y="2646000"/>
              <a:ext cx="67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CasellaDiTesto 86"/>
            <p:cNvSpPr/>
            <p:nvPr/>
          </p:nvSpPr>
          <p:spPr>
            <a:xfrm>
              <a:off x="4162320" y="2000160"/>
              <a:ext cx="365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01T14:25:54Z</dcterms:created>
  <dc:creator>User</dc:creator>
  <dc:description/>
  <dc:language>en-US</dc:language>
  <cp:lastModifiedBy>L.Latha</cp:lastModifiedBy>
  <cp:lastPrinted>2014-12-01T14:51:33Z</cp:lastPrinted>
  <dcterms:modified xsi:type="dcterms:W3CDTF">2015-08-18T10:39:54Z</dcterms:modified>
  <cp:revision>33</cp:revision>
  <dc:subject/>
  <dc:title>Presentazione standard di PowerPoint</dc:title>
</cp:coreProperties>
</file>